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6" r:id="rId2"/>
    <p:sldId id="258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3" d="100"/>
          <a:sy n="73" d="100"/>
        </p:scale>
        <p:origin x="2454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57DE74-BDB9-489D-B835-D934A1B09F98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BBC303-BC18-4D19-B714-215E19ADB1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7345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BBC303-BC18-4D19-B714-215E19ADB1A6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20852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7156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2799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3172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1797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7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3019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78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613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1349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4704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1860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AFBB46-986D-40DA-A897-27D27A2B8DD1}" type="datetimeFigureOut">
              <a:rPr lang="zh-CN" altLang="en-US" smtClean="0"/>
              <a:t>2021-07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EA8A3-9D96-432F-BF87-C48F05327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0223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"/><Relationship Id="rId5" Type="http://schemas.openxmlformats.org/officeDocument/2006/relationships/image" Target="../media/image10.tif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表, 折线图&#10;&#10;描述已自动生成">
            <a:extLst>
              <a:ext uri="{FF2B5EF4-FFF2-40B4-BE49-F238E27FC236}">
                <a16:creationId xmlns:a16="http://schemas.microsoft.com/office/drawing/2014/main" id="{A36622F3-9D77-40AE-BE0E-52B531D5CE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91586" y="2804020"/>
            <a:ext cx="2671589" cy="2137270"/>
          </a:xfrm>
          <a:prstGeom prst="rect">
            <a:avLst/>
          </a:prstGeom>
        </p:spPr>
      </p:pic>
      <p:pic>
        <p:nvPicPr>
          <p:cNvPr id="5" name="图片 4" descr="图表, 条形图&#10;&#10;描述已自动生成">
            <a:extLst>
              <a:ext uri="{FF2B5EF4-FFF2-40B4-BE49-F238E27FC236}">
                <a16:creationId xmlns:a16="http://schemas.microsoft.com/office/drawing/2014/main" id="{7DD59580-7EBD-4BFA-AFC5-8F0DF82403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5429" y="5336746"/>
            <a:ext cx="2870183" cy="1443114"/>
          </a:xfrm>
          <a:prstGeom prst="rect">
            <a:avLst/>
          </a:prstGeom>
        </p:spPr>
      </p:pic>
      <p:pic>
        <p:nvPicPr>
          <p:cNvPr id="6" name="图片 5" descr="图表, 折线图, 直方图&#10;&#10;描述已自动生成">
            <a:extLst>
              <a:ext uri="{FF2B5EF4-FFF2-40B4-BE49-F238E27FC236}">
                <a16:creationId xmlns:a16="http://schemas.microsoft.com/office/drawing/2014/main" id="{E916EFE5-3DDA-4B47-BE66-C3C26E9DA83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1397" y="549586"/>
            <a:ext cx="2958249" cy="1949169"/>
          </a:xfrm>
          <a:prstGeom prst="rect">
            <a:avLst/>
          </a:prstGeom>
        </p:spPr>
      </p:pic>
      <p:pic>
        <p:nvPicPr>
          <p:cNvPr id="7" name="图片 6" descr="图表, 折线图&#10;&#10;描述已自动生成">
            <a:extLst>
              <a:ext uri="{FF2B5EF4-FFF2-40B4-BE49-F238E27FC236}">
                <a16:creationId xmlns:a16="http://schemas.microsoft.com/office/drawing/2014/main" id="{047451C4-808B-4F24-AA00-4E1324A617A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1370" y="2809875"/>
            <a:ext cx="3058276" cy="2143125"/>
          </a:xfrm>
          <a:prstGeom prst="rect">
            <a:avLst/>
          </a:prstGeom>
        </p:spPr>
      </p:pic>
      <p:pic>
        <p:nvPicPr>
          <p:cNvPr id="8" name="图片 7" descr="图表, 折线图&#10;&#10;描述已自动生成">
            <a:extLst>
              <a:ext uri="{FF2B5EF4-FFF2-40B4-BE49-F238E27FC236}">
                <a16:creationId xmlns:a16="http://schemas.microsoft.com/office/drawing/2014/main" id="{D34A43BF-5AD4-49CF-90FE-ABE86290769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18356" y="549586"/>
            <a:ext cx="2612774" cy="2110423"/>
          </a:xfrm>
          <a:prstGeom prst="rect">
            <a:avLst/>
          </a:prstGeom>
        </p:spPr>
      </p:pic>
      <p:pic>
        <p:nvPicPr>
          <p:cNvPr id="9" name="图片 8" descr="图表&#10;&#10;描述已自动生成">
            <a:extLst>
              <a:ext uri="{FF2B5EF4-FFF2-40B4-BE49-F238E27FC236}">
                <a16:creationId xmlns:a16="http://schemas.microsoft.com/office/drawing/2014/main" id="{D95E39D7-79B1-444C-8963-06109F2D405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62390" y="5336745"/>
            <a:ext cx="2983399" cy="1426329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4D44419B-F96A-4A97-BD28-98A3D3D70E06}"/>
              </a:ext>
            </a:extLst>
          </p:cNvPr>
          <p:cNvSpPr txBox="1"/>
          <p:nvPr/>
        </p:nvSpPr>
        <p:spPr>
          <a:xfrm>
            <a:off x="181370" y="53800"/>
            <a:ext cx="259358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1088319-9CF3-4896-8C88-1140C294C6B5}"/>
              </a:ext>
            </a:extLst>
          </p:cNvPr>
          <p:cNvSpPr txBox="1"/>
          <p:nvPr/>
        </p:nvSpPr>
        <p:spPr>
          <a:xfrm>
            <a:off x="82242" y="7407246"/>
            <a:ext cx="6775758" cy="13450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altLang="zh-CN" sz="1400" b="1" dirty="0">
                <a:effectLst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upplementary figure 1.</a:t>
            </a:r>
            <a:r>
              <a:rPr lang="en-US" altLang="zh-CN" sz="1400" dirty="0">
                <a:effectLst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he quantile-quantile (Q-Q) plot of the inter-batch difference of datasets is removed using “</a:t>
            </a:r>
            <a:r>
              <a:rPr lang="en-US" altLang="zh-CN" sz="1400" i="1" dirty="0" err="1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va</a:t>
            </a:r>
            <a:r>
              <a:rPr lang="en-US" altLang="zh-CN" sz="1400" i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”</a:t>
            </a:r>
            <a:r>
              <a:rPr lang="en-US" altLang="zh-CN" sz="14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package (A-D).  Boxplots for the merged gene expression matrix before (E) and after (F) normalized and adjusted by </a:t>
            </a:r>
            <a:r>
              <a:rPr lang="en-US" altLang="zh-CN" sz="1400" dirty="0" err="1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omBat</a:t>
            </a:r>
            <a:r>
              <a:rPr lang="en-US" altLang="zh-CN" sz="14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and SVA methods. </a:t>
            </a:r>
            <a:endParaRPr lang="zh-CN" altLang="zh-CN" sz="14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6CEFD22-1CB1-4BF1-BFEF-D75D44575D63}"/>
              </a:ext>
            </a:extLst>
          </p:cNvPr>
          <p:cNvSpPr txBox="1"/>
          <p:nvPr/>
        </p:nvSpPr>
        <p:spPr>
          <a:xfrm>
            <a:off x="0" y="60255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DD93463-3228-40A7-8D9F-6F4024A89D95}"/>
              </a:ext>
            </a:extLst>
          </p:cNvPr>
          <p:cNvSpPr txBox="1"/>
          <p:nvPr/>
        </p:nvSpPr>
        <p:spPr>
          <a:xfrm>
            <a:off x="3300844" y="60255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973CE01-EB37-4149-BD94-683D31B4F61E}"/>
              </a:ext>
            </a:extLst>
          </p:cNvPr>
          <p:cNvSpPr txBox="1"/>
          <p:nvPr/>
        </p:nvSpPr>
        <p:spPr>
          <a:xfrm>
            <a:off x="0" y="289362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55E3D57-D190-4209-85A0-0A8CDBCEDB53}"/>
              </a:ext>
            </a:extLst>
          </p:cNvPr>
          <p:cNvSpPr txBox="1"/>
          <p:nvPr/>
        </p:nvSpPr>
        <p:spPr>
          <a:xfrm>
            <a:off x="3300844" y="289362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9858043-0711-4276-8E8B-111D4E35F084}"/>
              </a:ext>
            </a:extLst>
          </p:cNvPr>
          <p:cNvSpPr txBox="1"/>
          <p:nvPr/>
        </p:nvSpPr>
        <p:spPr>
          <a:xfrm>
            <a:off x="12093" y="531178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85F4AE6-06C2-4902-ADCD-4B2281F70D1E}"/>
              </a:ext>
            </a:extLst>
          </p:cNvPr>
          <p:cNvSpPr txBox="1"/>
          <p:nvPr/>
        </p:nvSpPr>
        <p:spPr>
          <a:xfrm>
            <a:off x="3300844" y="530757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48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4D44419B-F96A-4A97-BD28-98A3D3D70E06}"/>
              </a:ext>
            </a:extLst>
          </p:cNvPr>
          <p:cNvSpPr txBox="1"/>
          <p:nvPr/>
        </p:nvSpPr>
        <p:spPr>
          <a:xfrm>
            <a:off x="181370" y="53800"/>
            <a:ext cx="259358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12301D4-65FF-4727-A9A6-D9076B0A0694}"/>
              </a:ext>
            </a:extLst>
          </p:cNvPr>
          <p:cNvSpPr txBox="1"/>
          <p:nvPr/>
        </p:nvSpPr>
        <p:spPr>
          <a:xfrm>
            <a:off x="41121" y="5109777"/>
            <a:ext cx="6775758" cy="6987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altLang="zh-CN" sz="1400" b="1" dirty="0">
                <a:effectLst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upplementary figure </a:t>
            </a:r>
            <a:r>
              <a:rPr lang="en-US" altLang="zh-CN" sz="14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2</a:t>
            </a:r>
            <a:r>
              <a:rPr lang="en-US" altLang="zh-CN" sz="1400" b="1" dirty="0">
                <a:effectLst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.</a:t>
            </a:r>
            <a:r>
              <a:rPr lang="en-US" altLang="zh-CN" sz="1400" dirty="0">
                <a:effectLst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The differently expressed immune-related genes heatmap plot in diabetic nephropathy (DN) and control samples.</a:t>
            </a:r>
            <a:endParaRPr lang="zh-CN" altLang="zh-CN" sz="14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4" name="图片 3" descr="电脑屏幕的照片&#10;&#10;中度可信度描述已自动生成">
            <a:extLst>
              <a:ext uri="{FF2B5EF4-FFF2-40B4-BE49-F238E27FC236}">
                <a16:creationId xmlns:a16="http://schemas.microsoft.com/office/drawing/2014/main" id="{10679F69-83BA-440C-AE3D-1499DDDB24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92354"/>
            <a:ext cx="6858000" cy="47168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05608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47995F8-03D2-47D6-8902-66F9746865FD}"/>
              </a:ext>
            </a:extLst>
          </p:cNvPr>
          <p:cNvSpPr txBox="1"/>
          <p:nvPr/>
        </p:nvSpPr>
        <p:spPr>
          <a:xfrm>
            <a:off x="181370" y="53800"/>
            <a:ext cx="259358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7A7C69E-784D-4816-9298-E3D246A60F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16907" y="3107416"/>
            <a:ext cx="3376615" cy="22510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2C1BABA-D293-4F42-94DE-95DBE4933BB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93107" y="894441"/>
            <a:ext cx="3319463" cy="2212975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7FE3BF2-F2EB-4ACA-A857-54E4FF9F044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6963" y="3292082"/>
            <a:ext cx="3041534" cy="168974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4B95623-AC37-4756-B022-37AAC3F4953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8554" y="894441"/>
            <a:ext cx="2976148" cy="2232111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415AFCBB-6C92-4EB7-8A6B-D70DA2C31BD2}"/>
              </a:ext>
            </a:extLst>
          </p:cNvPr>
          <p:cNvSpPr txBox="1"/>
          <p:nvPr/>
        </p:nvSpPr>
        <p:spPr>
          <a:xfrm>
            <a:off x="26006" y="89444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8257CD4-7343-40AD-8EDC-A2559F467ED3}"/>
              </a:ext>
            </a:extLst>
          </p:cNvPr>
          <p:cNvSpPr txBox="1"/>
          <p:nvPr/>
        </p:nvSpPr>
        <p:spPr>
          <a:xfrm>
            <a:off x="3154553" y="89444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FC9B7BE-C6C3-4AF1-AD3B-24A4432FE39A}"/>
              </a:ext>
            </a:extLst>
          </p:cNvPr>
          <p:cNvSpPr txBox="1"/>
          <p:nvPr/>
        </p:nvSpPr>
        <p:spPr>
          <a:xfrm>
            <a:off x="0" y="31074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DB1DF7C-145F-4FC5-A4F9-F0ED1F65C9FA}"/>
              </a:ext>
            </a:extLst>
          </p:cNvPr>
          <p:cNvSpPr txBox="1"/>
          <p:nvPr/>
        </p:nvSpPr>
        <p:spPr>
          <a:xfrm>
            <a:off x="3154553" y="321219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C333AD1-6E62-4F98-8415-A1B2624B13A8}"/>
              </a:ext>
            </a:extLst>
          </p:cNvPr>
          <p:cNvSpPr txBox="1"/>
          <p:nvPr/>
        </p:nvSpPr>
        <p:spPr>
          <a:xfrm>
            <a:off x="36812" y="5864196"/>
            <a:ext cx="6775758" cy="23145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altLang="zh-CN" sz="1400" b="1" dirty="0">
                <a:effectLst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upplementary figure 3.</a:t>
            </a:r>
            <a:r>
              <a:rPr lang="en-US" altLang="zh-CN" sz="1400" dirty="0">
                <a:effectLst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 </a:t>
            </a:r>
            <a:r>
              <a:rPr lang="en-US" altLang="zh-CN" sz="14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WGCNA construction and modules detection. (A) Sample clustering of datasets. (B) Sample dendrogram and trait of infiltrated immune cells heatmap. (C) Analysis of soft-thresholding powers to fit the scale-free topology model and the mean connectivity of the soft-thresholding power; 10 was chosen as the value to construct a scale-free network. (D) Dendrogram of the gene modules. The branches represent different gene modules, and each leaf represents a gene in the cluster dendrogram. Different colors indicate different clusters.</a:t>
            </a:r>
            <a:endParaRPr lang="zh-CN" altLang="zh-CN" sz="14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4645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1</TotalTime>
  <Words>190</Words>
  <Application>Microsoft Office PowerPoint</Application>
  <PresentationFormat>A4 纸张(210x297 毫米)</PresentationFormat>
  <Paragraphs>17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阅军</dc:creator>
  <cp:lastModifiedBy>王 阅军</cp:lastModifiedBy>
  <cp:revision>17</cp:revision>
  <dcterms:created xsi:type="dcterms:W3CDTF">2021-04-11T14:51:29Z</dcterms:created>
  <dcterms:modified xsi:type="dcterms:W3CDTF">2021-07-18T00:00:29Z</dcterms:modified>
</cp:coreProperties>
</file>